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8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27609E-6660-C4B0-2C8B-E831CB5B11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9288117-CE32-2151-1371-66111BC09D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890A6F-D542-64C1-BBFC-5CEA91FD7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BB9E5A-7CC7-3B00-4FB1-EA96066C4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8942FA-E409-00E7-D983-2491C4577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319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F6ADB0-DAC5-7B9D-96ED-A059783C42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3E0C7A3-506B-4388-6E4E-8C41BE5FB4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E337C3-9100-CF93-89A1-84DFDE02E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26DE15-F0E8-BB2F-B909-8C76F972A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70150E-281D-46FB-9C81-3D363FA71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2957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747C082-8865-8EB3-FF49-14C485A7FE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6A4FAA5-AAF3-BE39-83D5-4DD7B73AA9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FE22B1-6B6C-7820-723C-696340AEE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7AFA11-500B-B6B6-45AF-531B5D2B0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5CDBC1-FDD8-30FC-E974-134C9BC22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8375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8ADD76-0343-2632-D74C-625EE56D8D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4C7F816-F4DA-7189-8FB7-2B27E34860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179198-7F81-0E41-3CC5-4AD36B9D8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D86CAB-1272-1856-CAC7-92C2FC868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9B01C2-2B12-DD69-053F-E8BE6E7CF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3366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58DA56-CA8A-2FC8-F438-6F767073B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72A80AC-D114-5972-E299-FAB796704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38E644-6A29-E755-ACDA-0E9DAA9FF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6FF517-6E95-DA5A-7686-D61112E8F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A78112-878B-ED12-1725-D0F3F7EB2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964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3FD2FD-59A8-AF6E-5004-4F968035E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F6DBB1-E335-2BD0-2F1C-BCC8B1A312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A4534B9-FE91-B54A-BCE2-5DDC1D5DB4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DF49C3-0D2B-2F04-9EEA-96FED9547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C9DA9A-C763-9BB3-4420-61D390E30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A22389F-0331-38A8-E897-8AFA199CF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067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BF6FB2-D564-250B-6F3C-03B5E125F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E22ED77-9F43-746E-5FED-EAFA2354D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F8CE241-8E90-A9E1-08C4-84346D0FDA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2903665-CD76-D69A-903E-BC2456BAE9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951B62C-2751-6CBE-DB8B-F9731D4DE0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9330F1A-FD2E-5049-F395-E11492B190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80FBDF0-1D6B-87BC-2CEC-819C423EC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AA52487-D4B7-BAFF-9D1A-949302BE7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9617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BFC1C8-D505-5F6D-F6F5-E00BCD94E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47B4EC2-55A3-71CD-AD20-B62A9F3C6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E8DEFD9-22EA-66F6-9992-BC5E7BB09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783E891-C561-B60E-02B0-DCAD715D1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9933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E83F85B-1214-6908-3740-FD6D4FF00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98DE074-2572-251D-ED5C-8D42D202B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689DEB5-2098-65D3-D4AF-C08B33014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736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0434B8-D243-31B7-07FA-3124D8848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502D9B-1DC2-CEED-0491-3DEC3DAAF5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3876E3F-787E-09EE-76EB-201A27541A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9120478-C839-6F3C-E60F-279892E9C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EDA519-1E27-39B5-FE4E-A3F4F4F60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7B0A317-2496-738B-A64C-7526D4D9C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1369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AE7BDF-FEC0-B3FB-BA33-1B05D2AD7B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4EA2B94-BF68-29A4-0F7A-A5BAD05915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80C124A-61D0-A96C-015E-2FF3CD6D15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A205E0-1EE9-92B1-8F9D-85C4B7440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C7D4AB5-4E82-4C8B-505A-6279F1679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1EAC5B-2CD5-C3E9-578B-8D969E91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4966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FC764E7-8806-2C35-14DA-B2135A991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330099-6B46-62DC-82C2-BAAB3437F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2847ED-9262-DC0B-190E-E6EDFDCDDC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92F5D-E02A-4B81-AEB0-0088A06B9A1F}" type="datetimeFigureOut">
              <a:rPr lang="zh-CN" altLang="en-US" smtClean="0"/>
              <a:t>2022-12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9C74DA-3EEC-8513-C0EB-CB2DEAE834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5A329C-BB79-E1A9-81CB-1450FB6C72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9E301-0BDF-46C8-8940-5F5256D9D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426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>
            <a:extLst>
              <a:ext uri="{FF2B5EF4-FFF2-40B4-BE49-F238E27FC236}">
                <a16:creationId xmlns:a16="http://schemas.microsoft.com/office/drawing/2014/main" id="{5703F828-9949-B1FD-6E8C-4003C0C1174A}"/>
              </a:ext>
            </a:extLst>
          </p:cNvPr>
          <p:cNvGrpSpPr/>
          <p:nvPr/>
        </p:nvGrpSpPr>
        <p:grpSpPr>
          <a:xfrm>
            <a:off x="2930265" y="1426126"/>
            <a:ext cx="6517907" cy="3202014"/>
            <a:chOff x="2930265" y="1426126"/>
            <a:chExt cx="6517907" cy="320201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E7A70D81-1324-CAC8-B37B-4F3C8E55C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0265" y="1666110"/>
              <a:ext cx="5626619" cy="2706630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2E5C6F7-3492-3E0F-AC6F-D22A5802AB18}"/>
                </a:ext>
              </a:extLst>
            </p:cNvPr>
            <p:cNvSpPr txBox="1"/>
            <p:nvPr/>
          </p:nvSpPr>
          <p:spPr>
            <a:xfrm flipH="1">
              <a:off x="3030316" y="4295050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Z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3E12372-3CFB-78A3-BCC6-F618A6AA1EEC}"/>
                </a:ext>
              </a:extLst>
            </p:cNvPr>
            <p:cNvSpPr txBox="1"/>
            <p:nvPr/>
          </p:nvSpPr>
          <p:spPr>
            <a:xfrm flipH="1">
              <a:off x="4318472" y="4320363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Z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6572A3B-8BCB-0179-41D3-6FB6AC07235A}"/>
                </a:ext>
              </a:extLst>
            </p:cNvPr>
            <p:cNvSpPr txBox="1"/>
            <p:nvPr/>
          </p:nvSpPr>
          <p:spPr>
            <a:xfrm flipH="1">
              <a:off x="3454152" y="4295051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Z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B3B2FC7-18A4-17E3-4B49-59564A5AADBB}"/>
                </a:ext>
              </a:extLst>
            </p:cNvPr>
            <p:cNvSpPr txBox="1"/>
            <p:nvPr/>
          </p:nvSpPr>
          <p:spPr>
            <a:xfrm flipH="1">
              <a:off x="4748413" y="4316355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Z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7F9AEE12-9D12-B8E9-AF50-A5532B2FC2E1}"/>
                </a:ext>
              </a:extLst>
            </p:cNvPr>
            <p:cNvSpPr txBox="1"/>
            <p:nvPr/>
          </p:nvSpPr>
          <p:spPr>
            <a:xfrm flipH="1">
              <a:off x="5188817" y="4314846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Z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7675C35-7166-D1AC-43C2-2FC166139C90}"/>
                </a:ext>
              </a:extLst>
            </p:cNvPr>
            <p:cNvSpPr txBox="1"/>
            <p:nvPr/>
          </p:nvSpPr>
          <p:spPr>
            <a:xfrm flipH="1">
              <a:off x="6883140" y="4295052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Z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C3D8677-18A0-1A40-50B8-589180FBF139}"/>
                </a:ext>
              </a:extLst>
            </p:cNvPr>
            <p:cNvSpPr txBox="1"/>
            <p:nvPr/>
          </p:nvSpPr>
          <p:spPr>
            <a:xfrm flipH="1">
              <a:off x="3815591" y="4295049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W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E90FC530-DEB8-8A5C-4F66-C42E7883CDF7}"/>
                </a:ext>
              </a:extLst>
            </p:cNvPr>
            <p:cNvSpPr txBox="1"/>
            <p:nvPr/>
          </p:nvSpPr>
          <p:spPr>
            <a:xfrm flipH="1">
              <a:off x="6434648" y="4314843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W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EDB274A-42DA-0E53-4374-6E444EFA9D9B}"/>
                </a:ext>
              </a:extLst>
            </p:cNvPr>
            <p:cNvSpPr txBox="1"/>
            <p:nvPr/>
          </p:nvSpPr>
          <p:spPr>
            <a:xfrm flipH="1">
              <a:off x="5950318" y="4314844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W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0F8102B-A67E-E7D2-339D-0BF698D363B6}"/>
                </a:ext>
              </a:extLst>
            </p:cNvPr>
            <p:cNvSpPr txBox="1"/>
            <p:nvPr/>
          </p:nvSpPr>
          <p:spPr>
            <a:xfrm flipH="1">
              <a:off x="5543724" y="4314845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W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847C70E-126C-7D67-816E-B9C6867FBE9B}"/>
                </a:ext>
              </a:extLst>
            </p:cNvPr>
            <p:cNvSpPr txBox="1"/>
            <p:nvPr/>
          </p:nvSpPr>
          <p:spPr>
            <a:xfrm flipH="1">
              <a:off x="7247836" y="4304947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W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A9F2DF9-7FEC-8E84-1A26-C86F12D59380}"/>
                </a:ext>
              </a:extLst>
            </p:cNvPr>
            <p:cNvSpPr txBox="1"/>
            <p:nvPr/>
          </p:nvSpPr>
          <p:spPr>
            <a:xfrm flipH="1">
              <a:off x="7720012" y="4304946"/>
              <a:ext cx="668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W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C02BC0E-7884-0A85-7DFD-926E1289A1C9}"/>
                </a:ext>
              </a:extLst>
            </p:cNvPr>
            <p:cNvSpPr txBox="1"/>
            <p:nvPr/>
          </p:nvSpPr>
          <p:spPr>
            <a:xfrm flipH="1">
              <a:off x="8054340" y="1426126"/>
              <a:ext cx="83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r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39E18A32-55D5-D82D-9C50-219A175AF1D9}"/>
                </a:ext>
              </a:extLst>
            </p:cNvPr>
            <p:cNvSpPr txBox="1"/>
            <p:nvPr/>
          </p:nvSpPr>
          <p:spPr>
            <a:xfrm flipH="1">
              <a:off x="8474494" y="2673547"/>
              <a:ext cx="9736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 bp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1317CDB-42C3-38CF-703D-D49B22E01474}"/>
                </a:ext>
              </a:extLst>
            </p:cNvPr>
            <p:cNvSpPr txBox="1"/>
            <p:nvPr/>
          </p:nvSpPr>
          <p:spPr>
            <a:xfrm flipH="1">
              <a:off x="8443596" y="3009201"/>
              <a:ext cx="9736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 bp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6742AD69-980D-F22A-03E2-150B950485FF}"/>
                </a:ext>
              </a:extLst>
            </p:cNvPr>
            <p:cNvSpPr txBox="1"/>
            <p:nvPr/>
          </p:nvSpPr>
          <p:spPr>
            <a:xfrm flipH="1">
              <a:off x="8463375" y="3171312"/>
              <a:ext cx="9736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0 bp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CD0E19C-48D8-2FFD-3F1A-FFC83E83E105}"/>
                </a:ext>
              </a:extLst>
            </p:cNvPr>
            <p:cNvSpPr txBox="1"/>
            <p:nvPr/>
          </p:nvSpPr>
          <p:spPr>
            <a:xfrm flipH="1">
              <a:off x="8474494" y="3328784"/>
              <a:ext cx="9736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 bp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5B781A1-D631-48FF-7BD6-7EEB62237806}"/>
                </a:ext>
              </a:extLst>
            </p:cNvPr>
            <p:cNvSpPr txBox="1"/>
            <p:nvPr/>
          </p:nvSpPr>
          <p:spPr>
            <a:xfrm flipH="1">
              <a:off x="8474494" y="3623084"/>
              <a:ext cx="9736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 bp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B5E6C24-89E6-C837-29FA-39B0A8F5CCC5}"/>
                </a:ext>
              </a:extLst>
            </p:cNvPr>
            <p:cNvSpPr txBox="1"/>
            <p:nvPr/>
          </p:nvSpPr>
          <p:spPr>
            <a:xfrm flipH="1">
              <a:off x="8466372" y="3920968"/>
              <a:ext cx="9736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bp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" name="文本框 25">
            <a:extLst>
              <a:ext uri="{FF2B5EF4-FFF2-40B4-BE49-F238E27FC236}">
                <a16:creationId xmlns:a16="http://schemas.microsoft.com/office/drawing/2014/main" id="{637FEC98-4E36-3E0E-85D3-6EB84768A7F8}"/>
              </a:ext>
            </a:extLst>
          </p:cNvPr>
          <p:cNvSpPr txBox="1"/>
          <p:nvPr/>
        </p:nvSpPr>
        <p:spPr>
          <a:xfrm>
            <a:off x="2850342" y="4822558"/>
            <a:ext cx="6491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PCR product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D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amplificatio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9932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913D78D-0C21-6E3B-DA13-2D25C8D309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4948" y="1428746"/>
            <a:ext cx="7562103" cy="327660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57D8A6D-FB3E-1E51-99BC-590EAB699347}"/>
              </a:ext>
            </a:extLst>
          </p:cNvPr>
          <p:cNvSpPr txBox="1"/>
          <p:nvPr/>
        </p:nvSpPr>
        <p:spPr>
          <a:xfrm>
            <a:off x="1943101" y="4822558"/>
            <a:ext cx="9705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Venn diagrams of circular RNAs expressed in each sample from same grou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9601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DAA08AA-5453-A267-CD62-AA5B9F0F68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4948" y="1326638"/>
            <a:ext cx="7562103" cy="325222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4B5C4F6-9FD9-FEC7-E1CC-D4B5A345756B}"/>
              </a:ext>
            </a:extLst>
          </p:cNvPr>
          <p:cNvSpPr txBox="1"/>
          <p:nvPr/>
        </p:nvSpPr>
        <p:spPr>
          <a:xfrm>
            <a:off x="1943101" y="4822558"/>
            <a:ext cx="97059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The expression of myoblast differentiation-related gene after overexpression and knock-down circGAS2-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2753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63</Words>
  <Application>Microsoft Office PowerPoint</Application>
  <PresentationFormat>宽屏</PresentationFormat>
  <Paragraphs>2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Biao</dc:creator>
  <cp:lastModifiedBy>Chen Biao</cp:lastModifiedBy>
  <cp:revision>8</cp:revision>
  <dcterms:created xsi:type="dcterms:W3CDTF">2022-11-01T08:59:52Z</dcterms:created>
  <dcterms:modified xsi:type="dcterms:W3CDTF">2022-12-23T08:16:11Z</dcterms:modified>
</cp:coreProperties>
</file>